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89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0678616"/>
              </p:ext>
            </p:extLst>
          </p:nvPr>
        </p:nvGraphicFramePr>
        <p:xfrm>
          <a:off x="146449" y="467544"/>
          <a:ext cx="6696746" cy="216789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2067659"/>
                <a:gridCol w="884669"/>
                <a:gridCol w="702447"/>
                <a:gridCol w="1097753"/>
                <a:gridCol w="1152128"/>
                <a:gridCol w="792090"/>
              </a:tblGrid>
              <a:tr h="29156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u="none" strike="noStrike" dirty="0">
                          <a:effectLst/>
                        </a:rPr>
                        <a:t>  </a:t>
                      </a:r>
                      <a:r>
                        <a:rPr lang="en-GB" sz="1600" b="0" u="none" strike="noStrike" dirty="0" smtClean="0">
                          <a:effectLst/>
                        </a:rPr>
                        <a:t>TRAINING SET</a:t>
                      </a:r>
                      <a:endParaRPr lang="en-GB" sz="2400" b="0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Control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TB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 smtClean="0">
                          <a:effectLst/>
                        </a:rPr>
                        <a:t>Sarcoidosi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 smtClean="0">
                          <a:effectLst/>
                        </a:rPr>
                        <a:t>Pneumonia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Cancer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87748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otal Number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367987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Mean age (rang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7 (18-68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9 (20-67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7 (25-79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63 (36-67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9 (44-72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286121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Gender (% mal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7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6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1029185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Ethnicity (%)  - White</a:t>
                      </a:r>
                      <a:br>
                        <a:rPr lang="en-GB" sz="1200" u="none" strike="noStrike" dirty="0" smtClean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Black</a:t>
                      </a:r>
                      <a:br>
                        <a:rPr lang="en-GB" sz="1200" u="none" strike="noStrike" dirty="0" smtClean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ISC</a:t>
                      </a:r>
                      <a:br>
                        <a:rPr lang="en-GB" sz="1200" u="none" strike="noStrike" dirty="0" smtClean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Middle  Eastern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57</a:t>
                      </a:r>
                      <a:r>
                        <a:rPr lang="en-GB" sz="1200" u="none" strike="noStrike" dirty="0">
                          <a:effectLst/>
                        </a:rPr>
                        <a:t/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26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6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7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31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31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64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2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6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75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2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1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7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3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4329722"/>
              </p:ext>
            </p:extLst>
          </p:nvPr>
        </p:nvGraphicFramePr>
        <p:xfrm>
          <a:off x="116632" y="2639359"/>
          <a:ext cx="6696744" cy="2349120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2016224"/>
                <a:gridCol w="864096"/>
                <a:gridCol w="884669"/>
                <a:gridCol w="915531"/>
                <a:gridCol w="1080120"/>
                <a:gridCol w="936104"/>
              </a:tblGrid>
              <a:tr h="31584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EST SET</a:t>
                      </a:r>
                      <a:endParaRPr lang="en-GB" sz="16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Control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TB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smtClean="0">
                          <a:effectLst/>
                        </a:rPr>
                        <a:t>Sarcoidosi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 smtClean="0">
                          <a:effectLst/>
                        </a:rPr>
                        <a:t>Pneumonia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Cancer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/>
                </a:tc>
              </a:tr>
              <a:tr h="18484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otal Number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</a:tr>
              <a:tr h="36968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Mean age (rang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5 (21-54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3 (</a:t>
                      </a:r>
                      <a:r>
                        <a:rPr lang="en-GB" sz="1200" u="none" strike="noStrike" dirty="0" smtClean="0">
                          <a:effectLst/>
                        </a:rPr>
                        <a:t>25-80</a:t>
                      </a:r>
                      <a:r>
                        <a:rPr lang="en-GB" sz="1200" u="none" strike="noStrike" dirty="0">
                          <a:effectLst/>
                        </a:rPr>
                        <a:t>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9 (20-83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9 (20-84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65 (38-87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</a:tr>
              <a:tr h="184843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Gender (% mal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7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6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</a:tr>
              <a:tr h="12939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Ethnicity </a:t>
                      </a:r>
                      <a:r>
                        <a:rPr lang="en-GB" sz="1200" u="none" strike="noStrike" dirty="0" smtClean="0">
                          <a:effectLst/>
                        </a:rPr>
                        <a:t>(%)  - </a:t>
                      </a:r>
                      <a:r>
                        <a:rPr lang="en-GB" sz="1200" u="none" strike="noStrike" dirty="0">
                          <a:effectLst/>
                        </a:rPr>
                        <a:t>White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Black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ISC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Middle Eastern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SE Asian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63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9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4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9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36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2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28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2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3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7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0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564165"/>
              </p:ext>
            </p:extLst>
          </p:nvPr>
        </p:nvGraphicFramePr>
        <p:xfrm>
          <a:off x="440669" y="5652121"/>
          <a:ext cx="5940659" cy="1872207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2138638"/>
                <a:gridCol w="1346549"/>
                <a:gridCol w="1108923"/>
                <a:gridCol w="1346549"/>
              </a:tblGrid>
              <a:tr h="29949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ALIDATION SET</a:t>
                      </a:r>
                      <a:endParaRPr lang="en-GB" sz="16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Control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>
                          <a:effectLst/>
                        </a:rPr>
                        <a:t>TB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u="none" strike="noStrike" dirty="0" smtClean="0">
                          <a:effectLst/>
                        </a:rPr>
                        <a:t>Sarcoidosis</a:t>
                      </a:r>
                      <a:endParaRPr lang="en-GB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b"/>
                </a:tc>
              </a:tr>
              <a:tr h="19401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otal Number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1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23987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Mean age (rang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4 (22-56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7 (27-83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45 (28-66</a:t>
                      </a:r>
                      <a:r>
                        <a:rPr lang="en-GB" sz="1200" u="none" strike="noStrike" dirty="0">
                          <a:effectLst/>
                        </a:rPr>
                        <a:t>)</a:t>
                      </a:r>
                      <a:endParaRPr lang="en-GB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194016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Gender (% male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2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  <a:tr h="94481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Ethnicity </a:t>
                      </a:r>
                      <a:r>
                        <a:rPr lang="en-GB" sz="1200" u="none" strike="noStrike" dirty="0" smtClean="0">
                          <a:effectLst/>
                        </a:rPr>
                        <a:t>(%)   - White </a:t>
                      </a:r>
                      <a:r>
                        <a:rPr lang="en-GB" sz="1200" u="none" strike="noStrike" dirty="0">
                          <a:effectLst/>
                        </a:rPr>
                        <a:t/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Black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ISC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                          - </a:t>
                      </a:r>
                      <a:r>
                        <a:rPr lang="en-GB" sz="1200" u="none" strike="noStrike" dirty="0">
                          <a:effectLst/>
                        </a:rPr>
                        <a:t>Central Asia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8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35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9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13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13</a:t>
                      </a:r>
                      <a:br>
                        <a:rPr lang="en-GB" sz="1200" u="none" strike="noStrike" dirty="0" smtClean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36</a:t>
                      </a:r>
                      <a:r>
                        <a:rPr lang="en-GB" sz="1200" u="none" strike="noStrike" dirty="0">
                          <a:effectLst/>
                        </a:rPr>
                        <a:t/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54</a:t>
                      </a:r>
                      <a:r>
                        <a:rPr lang="en-GB" sz="1200" u="none" strike="noStrike" dirty="0">
                          <a:effectLst/>
                        </a:rPr>
                        <a:t/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9</a:t>
                      </a:r>
                      <a:r>
                        <a:rPr lang="en-GB" sz="1200" u="none" strike="noStrike" dirty="0">
                          <a:effectLst/>
                        </a:rPr>
                        <a:t/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 smtClean="0">
                          <a:effectLst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715" marR="5715" marT="10160" marB="0" anchor="ctr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-76812" y="-1575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1A</a:t>
            </a:r>
            <a:endParaRPr lang="en-GB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2906" y="5210780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1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1379054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0</Words>
  <Application>Microsoft Office PowerPoint</Application>
  <PresentationFormat>On-screen Show (4:3)</PresentationFormat>
  <Paragraphs>8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1</cp:revision>
  <dcterms:created xsi:type="dcterms:W3CDTF">2013-03-09T22:22:05Z</dcterms:created>
  <dcterms:modified xsi:type="dcterms:W3CDTF">2013-03-09T22:23:06Z</dcterms:modified>
</cp:coreProperties>
</file>